
<file path=[Content_Types].xml><?xml version="1.0" encoding="utf-8"?>
<Types xmlns="http://schemas.openxmlformats.org/package/2006/content-types">
  <Default Extension="jpeg" ContentType="image/jpeg"/>
  <Default Extension="JPG" ContentType="image/.jpg"/>
  <Default Extension="emf" ContentType="image/x-emf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6119495" cy="467995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8" userDrawn="1">
          <p15:clr>
            <a:srgbClr val="A4A3A4"/>
          </p15:clr>
        </p15:guide>
        <p15:guide id="2" pos="20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158"/>
        <p:guide pos="20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37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65189" y="766024"/>
            <a:ext cx="4591136" cy="1629561"/>
          </a:xfrm>
        </p:spPr>
        <p:txBody>
          <a:bodyPr anchor="b"/>
          <a:lstStyle>
            <a:lvl1pPr algn="ctr">
              <a:defRPr sz="401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765189" y="2458427"/>
            <a:ext cx="4591136" cy="1130073"/>
          </a:xfrm>
        </p:spPr>
        <p:txBody>
          <a:bodyPr/>
          <a:lstStyle>
            <a:lvl1pPr marL="0" indent="0" algn="ctr">
              <a:buNone/>
              <a:defRPr sz="1605"/>
            </a:lvl1pPr>
            <a:lvl2pPr marL="306070" indent="0" algn="ctr">
              <a:buNone/>
              <a:defRPr sz="1340"/>
            </a:lvl2pPr>
            <a:lvl3pPr marL="612140" indent="0" algn="ctr">
              <a:buNone/>
              <a:defRPr sz="1205"/>
            </a:lvl3pPr>
            <a:lvl4pPr marL="918210" indent="0" algn="ctr">
              <a:buNone/>
              <a:defRPr sz="1070"/>
            </a:lvl4pPr>
            <a:lvl5pPr marL="1224280" indent="0" algn="ctr">
              <a:buNone/>
              <a:defRPr sz="1070"/>
            </a:lvl5pPr>
            <a:lvl6pPr marL="1529715" indent="0" algn="ctr">
              <a:buNone/>
              <a:defRPr sz="1070"/>
            </a:lvl6pPr>
            <a:lvl7pPr marL="1835785" indent="0" algn="ctr">
              <a:buNone/>
              <a:defRPr sz="1070"/>
            </a:lvl7pPr>
            <a:lvl8pPr marL="2141855" indent="0" algn="ctr">
              <a:buNone/>
              <a:defRPr sz="1070"/>
            </a:lvl8pPr>
            <a:lvl9pPr marL="2447925" indent="0" algn="ctr">
              <a:buNone/>
              <a:defRPr sz="107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380708" y="249201"/>
            <a:ext cx="1319952" cy="396663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20854" y="249201"/>
            <a:ext cx="3883335" cy="396663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17665" y="1166913"/>
            <a:ext cx="5279806" cy="1947021"/>
          </a:xfrm>
        </p:spPr>
        <p:txBody>
          <a:bodyPr anchor="b"/>
          <a:lstStyle>
            <a:lvl1pPr>
              <a:defRPr sz="401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17665" y="3132354"/>
            <a:ext cx="5279806" cy="1023892"/>
          </a:xfrm>
        </p:spPr>
        <p:txBody>
          <a:bodyPr/>
          <a:lstStyle>
            <a:lvl1pPr marL="0" indent="0">
              <a:buNone/>
              <a:defRPr sz="1605">
                <a:solidFill>
                  <a:schemeClr val="tx1">
                    <a:tint val="75000"/>
                  </a:schemeClr>
                </a:solidFill>
              </a:defRPr>
            </a:lvl1pPr>
            <a:lvl2pPr marL="306070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2pPr>
            <a:lvl3pPr marL="612140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210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4pPr>
            <a:lvl5pPr marL="1224280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5pPr>
            <a:lvl6pPr marL="152971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6pPr>
            <a:lvl7pPr marL="183578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7pPr>
            <a:lvl8pPr marL="214185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8pPr>
            <a:lvl9pPr marL="2447925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20854" y="1246007"/>
            <a:ext cx="2601644" cy="296983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099017" y="1246007"/>
            <a:ext cx="2601644" cy="296983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21652" y="249201"/>
            <a:ext cx="5279806" cy="90471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21652" y="1147410"/>
            <a:ext cx="2589688" cy="562328"/>
          </a:xfrm>
        </p:spPr>
        <p:txBody>
          <a:bodyPr anchor="b"/>
          <a:lstStyle>
            <a:lvl1pPr marL="0" indent="0">
              <a:buNone/>
              <a:defRPr sz="1605" b="1"/>
            </a:lvl1pPr>
            <a:lvl2pPr marL="306070" indent="0">
              <a:buNone/>
              <a:defRPr sz="1340" b="1"/>
            </a:lvl2pPr>
            <a:lvl3pPr marL="612140" indent="0">
              <a:buNone/>
              <a:defRPr sz="1205" b="1"/>
            </a:lvl3pPr>
            <a:lvl4pPr marL="918210" indent="0">
              <a:buNone/>
              <a:defRPr sz="1070" b="1"/>
            </a:lvl4pPr>
            <a:lvl5pPr marL="1224280" indent="0">
              <a:buNone/>
              <a:defRPr sz="1070" b="1"/>
            </a:lvl5pPr>
            <a:lvl6pPr marL="1529715" indent="0">
              <a:buNone/>
              <a:defRPr sz="1070" b="1"/>
            </a:lvl6pPr>
            <a:lvl7pPr marL="1835785" indent="0">
              <a:buNone/>
              <a:defRPr sz="1070" b="1"/>
            </a:lvl7pPr>
            <a:lvl8pPr marL="2141855" indent="0">
              <a:buNone/>
              <a:defRPr sz="1070" b="1"/>
            </a:lvl8pPr>
            <a:lvl9pPr marL="2447925" indent="0">
              <a:buNone/>
              <a:defRPr sz="10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21652" y="1709738"/>
            <a:ext cx="2589688" cy="251476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099017" y="1147410"/>
            <a:ext cx="2602441" cy="562328"/>
          </a:xfrm>
        </p:spPr>
        <p:txBody>
          <a:bodyPr anchor="b"/>
          <a:lstStyle>
            <a:lvl1pPr marL="0" indent="0">
              <a:buNone/>
              <a:defRPr sz="1605" b="1"/>
            </a:lvl1pPr>
            <a:lvl2pPr marL="306070" indent="0">
              <a:buNone/>
              <a:defRPr sz="1340" b="1"/>
            </a:lvl2pPr>
            <a:lvl3pPr marL="612140" indent="0">
              <a:buNone/>
              <a:defRPr sz="1205" b="1"/>
            </a:lvl3pPr>
            <a:lvl4pPr marL="918210" indent="0">
              <a:buNone/>
              <a:defRPr sz="1070" b="1"/>
            </a:lvl4pPr>
            <a:lvl5pPr marL="1224280" indent="0">
              <a:buNone/>
              <a:defRPr sz="1070" b="1"/>
            </a:lvl5pPr>
            <a:lvl6pPr marL="1529715" indent="0">
              <a:buNone/>
              <a:defRPr sz="1070" b="1"/>
            </a:lvl6pPr>
            <a:lvl7pPr marL="1835785" indent="0">
              <a:buNone/>
              <a:defRPr sz="1070" b="1"/>
            </a:lvl7pPr>
            <a:lvl8pPr marL="2141855" indent="0">
              <a:buNone/>
              <a:defRPr sz="1070" b="1"/>
            </a:lvl8pPr>
            <a:lvl9pPr marL="2447925" indent="0">
              <a:buNone/>
              <a:defRPr sz="107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099017" y="1709738"/>
            <a:ext cx="2602441" cy="251476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21652" y="312044"/>
            <a:ext cx="1974348" cy="1092152"/>
          </a:xfrm>
        </p:spPr>
        <p:txBody>
          <a:bodyPr anchor="b"/>
          <a:lstStyle>
            <a:lvl1pPr>
              <a:defRPr sz="214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02441" y="673927"/>
            <a:ext cx="3099017" cy="3326297"/>
          </a:xfrm>
        </p:spPr>
        <p:txBody>
          <a:bodyPr/>
          <a:lstStyle>
            <a:lvl1pPr>
              <a:defRPr sz="2140"/>
            </a:lvl1pPr>
            <a:lvl2pPr>
              <a:defRPr sz="1875"/>
            </a:lvl2pPr>
            <a:lvl3pPr>
              <a:defRPr sz="1605"/>
            </a:lvl3pPr>
            <a:lvl4pPr>
              <a:defRPr sz="1340"/>
            </a:lvl4pPr>
            <a:lvl5pPr>
              <a:defRPr sz="1340"/>
            </a:lvl5pPr>
            <a:lvl6pPr>
              <a:defRPr sz="1340"/>
            </a:lvl6pPr>
            <a:lvl7pPr>
              <a:defRPr sz="1340"/>
            </a:lvl7pPr>
            <a:lvl8pPr>
              <a:defRPr sz="1340"/>
            </a:lvl8pPr>
            <a:lvl9pPr>
              <a:defRPr sz="134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21652" y="1404195"/>
            <a:ext cx="1974348" cy="2601446"/>
          </a:xfrm>
        </p:spPr>
        <p:txBody>
          <a:bodyPr/>
          <a:lstStyle>
            <a:lvl1pPr marL="0" indent="0">
              <a:buNone/>
              <a:defRPr sz="1070"/>
            </a:lvl1pPr>
            <a:lvl2pPr marL="306070" indent="0">
              <a:buNone/>
              <a:defRPr sz="935"/>
            </a:lvl2pPr>
            <a:lvl3pPr marL="612140" indent="0">
              <a:buNone/>
              <a:defRPr sz="805"/>
            </a:lvl3pPr>
            <a:lvl4pPr marL="918210" indent="0">
              <a:buNone/>
              <a:defRPr sz="670"/>
            </a:lvl4pPr>
            <a:lvl5pPr marL="1224280" indent="0">
              <a:buNone/>
              <a:defRPr sz="670"/>
            </a:lvl5pPr>
            <a:lvl6pPr marL="1529715" indent="0">
              <a:buNone/>
              <a:defRPr sz="670"/>
            </a:lvl6pPr>
            <a:lvl7pPr marL="1835785" indent="0">
              <a:buNone/>
              <a:defRPr sz="670"/>
            </a:lvl7pPr>
            <a:lvl8pPr marL="2141855" indent="0">
              <a:buNone/>
              <a:defRPr sz="670"/>
            </a:lvl8pPr>
            <a:lvl9pPr marL="2447925" indent="0">
              <a:buNone/>
              <a:defRPr sz="67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21652" y="312044"/>
            <a:ext cx="1974348" cy="1092152"/>
          </a:xfrm>
        </p:spPr>
        <p:txBody>
          <a:bodyPr anchor="b"/>
          <a:lstStyle>
            <a:lvl1pPr>
              <a:defRPr sz="214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602441" y="673927"/>
            <a:ext cx="3099017" cy="3326297"/>
          </a:xfrm>
        </p:spPr>
        <p:txBody>
          <a:bodyPr/>
          <a:lstStyle>
            <a:lvl1pPr marL="0" indent="0">
              <a:buNone/>
              <a:defRPr sz="2140"/>
            </a:lvl1pPr>
            <a:lvl2pPr marL="306070" indent="0">
              <a:buNone/>
              <a:defRPr sz="1875"/>
            </a:lvl2pPr>
            <a:lvl3pPr marL="612140" indent="0">
              <a:buNone/>
              <a:defRPr sz="1605"/>
            </a:lvl3pPr>
            <a:lvl4pPr marL="918210" indent="0">
              <a:buNone/>
              <a:defRPr sz="1340"/>
            </a:lvl4pPr>
            <a:lvl5pPr marL="1224280" indent="0">
              <a:buNone/>
              <a:defRPr sz="1340"/>
            </a:lvl5pPr>
            <a:lvl6pPr marL="1529715" indent="0">
              <a:buNone/>
              <a:defRPr sz="1340"/>
            </a:lvl6pPr>
            <a:lvl7pPr marL="1835785" indent="0">
              <a:buNone/>
              <a:defRPr sz="1340"/>
            </a:lvl7pPr>
            <a:lvl8pPr marL="2141855" indent="0">
              <a:buNone/>
              <a:defRPr sz="1340"/>
            </a:lvl8pPr>
            <a:lvl9pPr marL="2447925" indent="0">
              <a:buNone/>
              <a:defRPr sz="134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21652" y="1404195"/>
            <a:ext cx="1974348" cy="2601446"/>
          </a:xfrm>
        </p:spPr>
        <p:txBody>
          <a:bodyPr/>
          <a:lstStyle>
            <a:lvl1pPr marL="0" indent="0">
              <a:buNone/>
              <a:defRPr sz="1070"/>
            </a:lvl1pPr>
            <a:lvl2pPr marL="306070" indent="0">
              <a:buNone/>
              <a:defRPr sz="935"/>
            </a:lvl2pPr>
            <a:lvl3pPr marL="612140" indent="0">
              <a:buNone/>
              <a:defRPr sz="805"/>
            </a:lvl3pPr>
            <a:lvl4pPr marL="918210" indent="0">
              <a:buNone/>
              <a:defRPr sz="670"/>
            </a:lvl4pPr>
            <a:lvl5pPr marL="1224280" indent="0">
              <a:buNone/>
              <a:defRPr sz="670"/>
            </a:lvl5pPr>
            <a:lvl6pPr marL="1529715" indent="0">
              <a:buNone/>
              <a:defRPr sz="670"/>
            </a:lvl6pPr>
            <a:lvl7pPr marL="1835785" indent="0">
              <a:buNone/>
              <a:defRPr sz="670"/>
            </a:lvl7pPr>
            <a:lvl8pPr marL="2141855" indent="0">
              <a:buNone/>
              <a:defRPr sz="670"/>
            </a:lvl8pPr>
            <a:lvl9pPr marL="2447925" indent="0">
              <a:buNone/>
              <a:defRPr sz="67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20854" y="249201"/>
            <a:ext cx="5279806" cy="9047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20854" y="1246007"/>
            <a:ext cx="5279806" cy="29698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20854" y="4338271"/>
            <a:ext cx="1377341" cy="24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027751" y="4338271"/>
            <a:ext cx="2066011" cy="24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323320" y="4338271"/>
            <a:ext cx="1377341" cy="2492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12140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35" indent="-153035" algn="l" defTabSz="61214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1875" kern="1200">
          <a:solidFill>
            <a:schemeClr val="tx1"/>
          </a:solidFill>
          <a:latin typeface="+mn-lt"/>
          <a:ea typeface="+mn-ea"/>
          <a:cs typeface="+mn-cs"/>
        </a:defRPr>
      </a:lvl1pPr>
      <a:lvl2pPr marL="459105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605" kern="1200">
          <a:solidFill>
            <a:schemeClr val="tx1"/>
          </a:solidFill>
          <a:latin typeface="+mn-lt"/>
          <a:ea typeface="+mn-ea"/>
          <a:cs typeface="+mn-cs"/>
        </a:defRPr>
      </a:lvl2pPr>
      <a:lvl3pPr marL="765175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340" kern="1200">
          <a:solidFill>
            <a:schemeClr val="tx1"/>
          </a:solidFill>
          <a:latin typeface="+mn-lt"/>
          <a:ea typeface="+mn-ea"/>
          <a:cs typeface="+mn-cs"/>
        </a:defRPr>
      </a:lvl3pPr>
      <a:lvl4pPr marL="1071245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315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2750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8820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4890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0960" indent="-153035" algn="l" defTabSz="612140" rtl="0" eaLnBrk="1" latinLnBrk="0" hangingPunct="1">
        <a:lnSpc>
          <a:spcPct val="90000"/>
        </a:lnSpc>
        <a:spcBef>
          <a:spcPct val="67000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7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14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21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280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29715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5785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1855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7925" algn="l" defTabSz="612140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5.xml"/><Relationship Id="rId8" Type="http://schemas.openxmlformats.org/officeDocument/2006/relationships/image" Target="../media/image4.emf"/><Relationship Id="rId7" Type="http://schemas.openxmlformats.org/officeDocument/2006/relationships/tags" Target="../tags/tag4.xml"/><Relationship Id="rId6" Type="http://schemas.openxmlformats.org/officeDocument/2006/relationships/image" Target="../media/image3.emf"/><Relationship Id="rId5" Type="http://schemas.openxmlformats.org/officeDocument/2006/relationships/tags" Target="../tags/tag3.xml"/><Relationship Id="rId47" Type="http://schemas.openxmlformats.org/officeDocument/2006/relationships/slideLayout" Target="../slideLayouts/slideLayout1.xml"/><Relationship Id="rId46" Type="http://schemas.openxmlformats.org/officeDocument/2006/relationships/tags" Target="../tags/tag36.xml"/><Relationship Id="rId45" Type="http://schemas.openxmlformats.org/officeDocument/2006/relationships/tags" Target="../tags/tag35.xml"/><Relationship Id="rId44" Type="http://schemas.openxmlformats.org/officeDocument/2006/relationships/tags" Target="../tags/tag34.xml"/><Relationship Id="rId43" Type="http://schemas.openxmlformats.org/officeDocument/2006/relationships/tags" Target="../tags/tag33.xml"/><Relationship Id="rId42" Type="http://schemas.openxmlformats.org/officeDocument/2006/relationships/tags" Target="../tags/tag32.xml"/><Relationship Id="rId41" Type="http://schemas.openxmlformats.org/officeDocument/2006/relationships/tags" Target="../tags/tag31.xml"/><Relationship Id="rId40" Type="http://schemas.openxmlformats.org/officeDocument/2006/relationships/tags" Target="../tags/tag30.xml"/><Relationship Id="rId4" Type="http://schemas.openxmlformats.org/officeDocument/2006/relationships/image" Target="../media/image2.emf"/><Relationship Id="rId39" Type="http://schemas.openxmlformats.org/officeDocument/2006/relationships/tags" Target="../tags/tag29.xml"/><Relationship Id="rId38" Type="http://schemas.openxmlformats.org/officeDocument/2006/relationships/tags" Target="../tags/tag28.xml"/><Relationship Id="rId37" Type="http://schemas.openxmlformats.org/officeDocument/2006/relationships/image" Target="../media/image10.tiff"/><Relationship Id="rId36" Type="http://schemas.openxmlformats.org/officeDocument/2006/relationships/tags" Target="../tags/tag27.xml"/><Relationship Id="rId35" Type="http://schemas.openxmlformats.org/officeDocument/2006/relationships/tags" Target="../tags/tag26.xml"/><Relationship Id="rId34" Type="http://schemas.openxmlformats.org/officeDocument/2006/relationships/tags" Target="../tags/tag25.xml"/><Relationship Id="rId33" Type="http://schemas.openxmlformats.org/officeDocument/2006/relationships/tags" Target="../tags/tag24.xml"/><Relationship Id="rId32" Type="http://schemas.openxmlformats.org/officeDocument/2006/relationships/tags" Target="../tags/tag23.xml"/><Relationship Id="rId31" Type="http://schemas.openxmlformats.org/officeDocument/2006/relationships/tags" Target="../tags/tag22.xml"/><Relationship Id="rId30" Type="http://schemas.openxmlformats.org/officeDocument/2006/relationships/tags" Target="../tags/tag21.xml"/><Relationship Id="rId3" Type="http://schemas.openxmlformats.org/officeDocument/2006/relationships/tags" Target="../tags/tag2.xml"/><Relationship Id="rId29" Type="http://schemas.openxmlformats.org/officeDocument/2006/relationships/tags" Target="../tags/tag20.xml"/><Relationship Id="rId28" Type="http://schemas.openxmlformats.org/officeDocument/2006/relationships/tags" Target="../tags/tag19.xml"/><Relationship Id="rId27" Type="http://schemas.openxmlformats.org/officeDocument/2006/relationships/tags" Target="../tags/tag18.xml"/><Relationship Id="rId26" Type="http://schemas.openxmlformats.org/officeDocument/2006/relationships/tags" Target="../tags/tag17.xml"/><Relationship Id="rId25" Type="http://schemas.openxmlformats.org/officeDocument/2006/relationships/tags" Target="../tags/tag16.xml"/><Relationship Id="rId24" Type="http://schemas.openxmlformats.org/officeDocument/2006/relationships/tags" Target="../tags/tag15.xml"/><Relationship Id="rId23" Type="http://schemas.openxmlformats.org/officeDocument/2006/relationships/tags" Target="../tags/tag14.xml"/><Relationship Id="rId22" Type="http://schemas.openxmlformats.org/officeDocument/2006/relationships/tags" Target="../tags/tag13.xml"/><Relationship Id="rId21" Type="http://schemas.openxmlformats.org/officeDocument/2006/relationships/tags" Target="../tags/tag12.xml"/><Relationship Id="rId20" Type="http://schemas.openxmlformats.org/officeDocument/2006/relationships/tags" Target="../tags/tag11.xml"/><Relationship Id="rId2" Type="http://schemas.openxmlformats.org/officeDocument/2006/relationships/image" Target="../media/image1.emf"/><Relationship Id="rId19" Type="http://schemas.openxmlformats.org/officeDocument/2006/relationships/tags" Target="../tags/tag10.xml"/><Relationship Id="rId18" Type="http://schemas.openxmlformats.org/officeDocument/2006/relationships/image" Target="../media/image9.tiff"/><Relationship Id="rId17" Type="http://schemas.openxmlformats.org/officeDocument/2006/relationships/tags" Target="../tags/tag9.xml"/><Relationship Id="rId16" Type="http://schemas.openxmlformats.org/officeDocument/2006/relationships/image" Target="../media/image8.tiff"/><Relationship Id="rId15" Type="http://schemas.openxmlformats.org/officeDocument/2006/relationships/tags" Target="../tags/tag8.xml"/><Relationship Id="rId14" Type="http://schemas.openxmlformats.org/officeDocument/2006/relationships/image" Target="../media/image7.tiff"/><Relationship Id="rId13" Type="http://schemas.openxmlformats.org/officeDocument/2006/relationships/tags" Target="../tags/tag7.xml"/><Relationship Id="rId12" Type="http://schemas.openxmlformats.org/officeDocument/2006/relationships/image" Target="../media/image6.tiff"/><Relationship Id="rId11" Type="http://schemas.openxmlformats.org/officeDocument/2006/relationships/tags" Target="../tags/tag6.xml"/><Relationship Id="rId10" Type="http://schemas.openxmlformats.org/officeDocument/2006/relationships/image" Target="../media/image5.tiff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3263900" y="509270"/>
            <a:ext cx="2189391" cy="2124000"/>
            <a:chOff x="5137" y="1695"/>
            <a:chExt cx="2953" cy="2865"/>
          </a:xfrm>
        </p:grpSpPr>
        <p:pic>
          <p:nvPicPr>
            <p:cNvPr id="3" name="图片 2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rcRect t="8333" r="6016" b="7319"/>
            <a:stretch>
              <a:fillRect/>
            </a:stretch>
          </p:blipFill>
          <p:spPr>
            <a:xfrm>
              <a:off x="5145" y="1695"/>
              <a:ext cx="1414" cy="1419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rcRect l="3846" t="9347" r="6558" b="8818"/>
            <a:stretch>
              <a:fillRect/>
            </a:stretch>
          </p:blipFill>
          <p:spPr>
            <a:xfrm>
              <a:off x="6712" y="1697"/>
              <a:ext cx="1379" cy="1407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6"/>
            <a:srcRect t="8818" r="6016" b="8333"/>
            <a:stretch>
              <a:fillRect/>
            </a:stretch>
          </p:blipFill>
          <p:spPr>
            <a:xfrm>
              <a:off x="5137" y="3112"/>
              <a:ext cx="1444" cy="1423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>
              <p:custDataLst>
                <p:tags r:id="rId7"/>
              </p:custDataLst>
            </p:nvPr>
          </p:nvPicPr>
          <p:blipFill>
            <a:blip r:embed="rId8"/>
            <a:srcRect t="10317" r="6016" b="8333"/>
            <a:stretch>
              <a:fillRect/>
            </a:stretch>
          </p:blipFill>
          <p:spPr>
            <a:xfrm>
              <a:off x="6654" y="3170"/>
              <a:ext cx="1437" cy="1391"/>
            </a:xfrm>
            <a:prstGeom prst="rect">
              <a:avLst/>
            </a:prstGeom>
          </p:spPr>
        </p:pic>
      </p:grpSp>
      <p:pic>
        <p:nvPicPr>
          <p:cNvPr id="7" name="图片 6" descr="CD107A-2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rcRect t="26698" r="12260" b="10448"/>
          <a:stretch>
            <a:fillRect/>
          </a:stretch>
        </p:blipFill>
        <p:spPr>
          <a:xfrm>
            <a:off x="4362229" y="3171638"/>
            <a:ext cx="1476000" cy="1472671"/>
          </a:xfrm>
          <a:prstGeom prst="rect">
            <a:avLst/>
          </a:prstGeom>
        </p:spPr>
      </p:pic>
      <p:pic>
        <p:nvPicPr>
          <p:cNvPr id="8" name="图片 7" descr="gzbm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rcRect l="1730" r="53751" b="5536"/>
          <a:stretch>
            <a:fillRect/>
          </a:stretch>
        </p:blipFill>
        <p:spPr>
          <a:xfrm>
            <a:off x="1477645" y="454025"/>
            <a:ext cx="1036342" cy="1080000"/>
          </a:xfrm>
          <a:prstGeom prst="rect">
            <a:avLst/>
          </a:prstGeom>
        </p:spPr>
      </p:pic>
      <p:pic>
        <p:nvPicPr>
          <p:cNvPr id="9" name="图片 8" descr="2Layout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/>
          <a:srcRect l="41989" t="8015" r="1099" b="33477"/>
          <a:stretch>
            <a:fillRect/>
          </a:stretch>
        </p:blipFill>
        <p:spPr>
          <a:xfrm>
            <a:off x="380365" y="1551305"/>
            <a:ext cx="2146300" cy="1038225"/>
          </a:xfrm>
          <a:prstGeom prst="rect">
            <a:avLst/>
          </a:prstGeom>
        </p:spPr>
      </p:pic>
      <p:pic>
        <p:nvPicPr>
          <p:cNvPr id="10" name="图片 9" descr="Data 1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16"/>
          <a:srcRect l="9646" r="11803"/>
          <a:stretch>
            <a:fillRect/>
          </a:stretch>
        </p:blipFill>
        <p:spPr>
          <a:xfrm>
            <a:off x="175895" y="3168650"/>
            <a:ext cx="1296000" cy="1445745"/>
          </a:xfrm>
          <a:prstGeom prst="rect">
            <a:avLst/>
          </a:prstGeom>
        </p:spPr>
      </p:pic>
      <p:pic>
        <p:nvPicPr>
          <p:cNvPr id="11" name="图片 10" descr="2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/>
          <a:srcRect l="8043" r="12103"/>
          <a:stretch>
            <a:fillRect/>
          </a:stretch>
        </p:blipFill>
        <p:spPr>
          <a:xfrm>
            <a:off x="1516380" y="3196590"/>
            <a:ext cx="1389340" cy="1404000"/>
          </a:xfrm>
          <a:prstGeom prst="rect">
            <a:avLst/>
          </a:prstGeom>
        </p:spPr>
      </p:pic>
      <p:pic>
        <p:nvPicPr>
          <p:cNvPr id="12" name="图片 11" descr="gzbm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12"/>
          <a:srcRect l="52836" t="5112" r="1758" b="4090"/>
          <a:stretch>
            <a:fillRect/>
          </a:stretch>
        </p:blipFill>
        <p:spPr>
          <a:xfrm>
            <a:off x="386080" y="498475"/>
            <a:ext cx="1061904" cy="1044000"/>
          </a:xfrm>
          <a:prstGeom prst="rect">
            <a:avLst/>
          </a:prstGeom>
        </p:spPr>
      </p:pic>
      <p:graphicFrame>
        <p:nvGraphicFramePr>
          <p:cNvPr id="13" name="表格 12"/>
          <p:cNvGraphicFramePr/>
          <p:nvPr>
            <p:custDataLst>
              <p:tags r:id="rId20"/>
            </p:custDataLst>
          </p:nvPr>
        </p:nvGraphicFramePr>
        <p:xfrm>
          <a:off x="175895" y="240030"/>
          <a:ext cx="5326380" cy="2584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31595"/>
                <a:gridCol w="1331595"/>
                <a:gridCol w="1331595"/>
                <a:gridCol w="1331595"/>
              </a:tblGrid>
              <a:tr h="258445"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c-NK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 anchorCtr="0">
                    <a:noFill/>
                  </a:tcPr>
                </a:tc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CIML NK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 anchorCtr="0">
                    <a:noFill/>
                  </a:tcPr>
                </a:tc>
                <a:tc>
                  <a:txBody>
                    <a:bodyPr/>
                    <a:p>
                      <a:pPr algn="ctr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c-NK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 anchorCtr="0">
                    <a:noFill/>
                  </a:tcPr>
                </a:tc>
                <a:tc>
                  <a:txBody>
                    <a:bodyPr/>
                    <a:p>
                      <a:pPr algn="l">
                        <a:buNone/>
                      </a:pPr>
                      <a:r>
                        <a:rPr lang="en-US" altLang="zh-CN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CIML NK</a:t>
                      </a:r>
                      <a:endParaRPr lang="en-US" altLang="zh-CN" sz="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 anchorCtr="0">
                    <a:noFill/>
                  </a:tcPr>
                </a:tc>
              </a:tr>
            </a:tbl>
          </a:graphicData>
        </a:graphic>
      </p:graphicFrame>
      <p:cxnSp>
        <p:nvCxnSpPr>
          <p:cNvPr id="14" name="直接箭头连接符 13"/>
          <p:cNvCxnSpPr/>
          <p:nvPr>
            <p:custDataLst>
              <p:tags r:id="rId21"/>
            </p:custDataLst>
          </p:nvPr>
        </p:nvCxnSpPr>
        <p:spPr>
          <a:xfrm>
            <a:off x="386080" y="2690495"/>
            <a:ext cx="11576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>
            <p:custDataLst>
              <p:tags r:id="rId22"/>
            </p:custDataLst>
          </p:nvPr>
        </p:nvSpPr>
        <p:spPr>
          <a:xfrm>
            <a:off x="1473200" y="2554605"/>
            <a:ext cx="177419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Grazyme B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箭头连接符 16"/>
          <p:cNvCxnSpPr/>
          <p:nvPr>
            <p:custDataLst>
              <p:tags r:id="rId23"/>
            </p:custDataLst>
          </p:nvPr>
        </p:nvCxnSpPr>
        <p:spPr>
          <a:xfrm>
            <a:off x="3247390" y="2710815"/>
            <a:ext cx="11576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>
            <p:custDataLst>
              <p:tags r:id="rId24"/>
            </p:custDataLst>
          </p:nvPr>
        </p:nvCxnSpPr>
        <p:spPr>
          <a:xfrm flipV="1">
            <a:off x="288290" y="1956435"/>
            <a:ext cx="6985" cy="67754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>
            <p:custDataLst>
              <p:tags r:id="rId25"/>
            </p:custDataLst>
          </p:nvPr>
        </p:nvSpPr>
        <p:spPr>
          <a:xfrm>
            <a:off x="111125" y="683260"/>
            <a:ext cx="305435" cy="11931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% of Max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箭头连接符 20"/>
          <p:cNvCxnSpPr/>
          <p:nvPr>
            <p:custDataLst>
              <p:tags r:id="rId26"/>
            </p:custDataLst>
          </p:nvPr>
        </p:nvCxnSpPr>
        <p:spPr>
          <a:xfrm flipV="1">
            <a:off x="3202940" y="1876425"/>
            <a:ext cx="6985" cy="67754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>
            <p:custDataLst>
              <p:tags r:id="rId27"/>
            </p:custDataLst>
          </p:nvPr>
        </p:nvSpPr>
        <p:spPr>
          <a:xfrm>
            <a:off x="3032760" y="1261745"/>
            <a:ext cx="305435" cy="56896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28"/>
            </p:custDataLst>
          </p:nvPr>
        </p:nvSpPr>
        <p:spPr>
          <a:xfrm>
            <a:off x="2406650" y="730250"/>
            <a:ext cx="9696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29"/>
            </p:custDataLst>
          </p:nvPr>
        </p:nvSpPr>
        <p:spPr>
          <a:xfrm>
            <a:off x="2458085" y="1784985"/>
            <a:ext cx="9696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SK-Hep-1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>
            <p:custDataLst>
              <p:tags r:id="rId30"/>
            </p:custDataLst>
          </p:nvPr>
        </p:nvSpPr>
        <p:spPr>
          <a:xfrm>
            <a:off x="106045" y="-15875"/>
            <a:ext cx="2114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>
            <p:custDataLst>
              <p:tags r:id="rId31"/>
            </p:custDataLst>
          </p:nvPr>
        </p:nvSpPr>
        <p:spPr>
          <a:xfrm>
            <a:off x="3173095" y="-8255"/>
            <a:ext cx="2114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32"/>
            </p:custDataLst>
          </p:nvPr>
        </p:nvSpPr>
        <p:spPr>
          <a:xfrm>
            <a:off x="64135" y="2833370"/>
            <a:ext cx="222250" cy="3575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33"/>
            </p:custDataLst>
          </p:nvPr>
        </p:nvSpPr>
        <p:spPr>
          <a:xfrm>
            <a:off x="3164205" y="2839720"/>
            <a:ext cx="222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34"/>
            </p:custDataLst>
          </p:nvPr>
        </p:nvSpPr>
        <p:spPr>
          <a:xfrm>
            <a:off x="5454015" y="722630"/>
            <a:ext cx="9696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>
            <p:custDataLst>
              <p:tags r:id="rId35"/>
            </p:custDataLst>
          </p:nvPr>
        </p:nvSpPr>
        <p:spPr>
          <a:xfrm>
            <a:off x="5420360" y="1771650"/>
            <a:ext cx="9696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SK-Hep-1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 descr="cd107"/>
          <p:cNvPicPr>
            <a:picLocks noChangeAspect="1"/>
          </p:cNvPicPr>
          <p:nvPr>
            <p:custDataLst>
              <p:tags r:id="rId36"/>
            </p:custDataLst>
          </p:nvPr>
        </p:nvPicPr>
        <p:blipFill>
          <a:blip r:embed="rId37"/>
          <a:srcRect r="13854" b="10633"/>
          <a:stretch>
            <a:fillRect/>
          </a:stretch>
        </p:blipFill>
        <p:spPr>
          <a:xfrm>
            <a:off x="2950210" y="3165475"/>
            <a:ext cx="1367790" cy="1451610"/>
          </a:xfrm>
          <a:prstGeom prst="rect">
            <a:avLst/>
          </a:prstGeom>
        </p:spPr>
      </p:pic>
      <p:sp>
        <p:nvSpPr>
          <p:cNvPr id="38" name="文本框 37"/>
          <p:cNvSpPr txBox="1"/>
          <p:nvPr>
            <p:custDataLst>
              <p:tags r:id="rId38"/>
            </p:custDataLst>
          </p:nvPr>
        </p:nvSpPr>
        <p:spPr>
          <a:xfrm>
            <a:off x="4362450" y="2580005"/>
            <a:ext cx="8864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CD107a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>
            <p:custDataLst>
              <p:tags r:id="rId39"/>
            </p:custDataLst>
          </p:nvPr>
        </p:nvSpPr>
        <p:spPr>
          <a:xfrm>
            <a:off x="624205" y="2966085"/>
            <a:ext cx="96964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+HepG2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40"/>
            </p:custDataLst>
          </p:nvPr>
        </p:nvSpPr>
        <p:spPr>
          <a:xfrm>
            <a:off x="2062480" y="2958465"/>
            <a:ext cx="96964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+SK-Hep-1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41"/>
            </p:custDataLst>
          </p:nvPr>
        </p:nvSpPr>
        <p:spPr>
          <a:xfrm>
            <a:off x="4889500" y="2952750"/>
            <a:ext cx="96964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+SK-Hep-1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42"/>
            </p:custDataLst>
          </p:nvPr>
        </p:nvSpPr>
        <p:spPr>
          <a:xfrm>
            <a:off x="3519170" y="2956560"/>
            <a:ext cx="96964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+HepG2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43"/>
            </p:custDataLst>
          </p:nvPr>
        </p:nvSpPr>
        <p:spPr>
          <a:xfrm>
            <a:off x="3786505" y="822325"/>
            <a:ext cx="356235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pPr algn="ct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1.8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>
            <p:custDataLst>
              <p:tags r:id="rId44"/>
            </p:custDataLst>
          </p:nvPr>
        </p:nvSpPr>
        <p:spPr>
          <a:xfrm>
            <a:off x="4869180" y="813435"/>
            <a:ext cx="356235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pPr algn="ct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56.9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>
            <p:custDataLst>
              <p:tags r:id="rId45"/>
            </p:custDataLst>
          </p:nvPr>
        </p:nvSpPr>
        <p:spPr>
          <a:xfrm>
            <a:off x="4869180" y="1897380"/>
            <a:ext cx="356235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pPr algn="ct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23.4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/>
          <p:cNvSpPr txBox="1"/>
          <p:nvPr>
            <p:custDataLst>
              <p:tags r:id="rId46"/>
            </p:custDataLst>
          </p:nvPr>
        </p:nvSpPr>
        <p:spPr>
          <a:xfrm>
            <a:off x="3773805" y="1864360"/>
            <a:ext cx="356235" cy="122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p>
            <a:pPr algn="ct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0.7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TABLE_ENDDRAG_ORIGIN_RECT" val="419*15"/>
  <p:tag name="TABLE_ENDDRAG_RECT" val="13*28*419*15"/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COMMONDATA" val="eyJoZGlkIjoiNThkNzY2MTkyODBhYjIzY2IxYWI0Y2IyMThmNzM4ZTkifQ=="/>
  <p:tag name="KSO_WPP_MARK_KEY" val="469a71ff-575d-47fb-8f36-37ddf22514a9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4</Words>
  <Application>WPS 演示</Application>
  <PresentationFormat>宽屏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微软雅黑</vt:lpstr>
      <vt:lpstr>Arial Unicode MS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ll</dc:creator>
  <cp:lastModifiedBy>邵洁</cp:lastModifiedBy>
  <cp:revision>7</cp:revision>
  <dcterms:created xsi:type="dcterms:W3CDTF">2023-02-16T14:24:00Z</dcterms:created>
  <dcterms:modified xsi:type="dcterms:W3CDTF">2023-02-18T08:47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54665B0AAFA46E293C30C822A3FD1A9</vt:lpwstr>
  </property>
  <property fmtid="{D5CDD505-2E9C-101B-9397-08002B2CF9AE}" pid="3" name="KSOProductBuildVer">
    <vt:lpwstr>2052-11.1.0.13703</vt:lpwstr>
  </property>
</Properties>
</file>